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1AE88D-0022-470C-BAD2-66F800D510A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E406BF-53AA-4FD4-AFC3-F7D1F13E51E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221817-CDF0-4B31-824A-6D8F3813F73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5CCEA8-6AF4-49CB-8DDB-83333A78367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27EC14-1368-4550-8794-56000A67BB7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11FF19-B1E5-4BA7-BC9E-2326A2D5CC2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407935-D098-4900-A3EB-31A35549BB0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2E1EDD-78CF-4A61-974C-C7543A51044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CCC4F2-F886-45AE-9801-CA70982100D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4DEC50-6929-44BC-B9E8-F305A82850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6D5189-05DF-482D-9001-AB07DA0108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854601-B560-4DD4-80D6-620BC9900A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63E0911-8607-4527-8FAF-DBAB4B53C1DC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003320" y="1379520"/>
          <a:ext cx="6934320" cy="1690560"/>
        </p:xfrm>
        <a:graphic>
          <a:graphicData uri="http://schemas.openxmlformats.org/drawingml/2006/table">
            <a:tbl>
              <a:tblPr/>
              <a:tblGrid>
                <a:gridCol w="825480"/>
                <a:gridCol w="825480"/>
                <a:gridCol w="825480"/>
                <a:gridCol w="825480"/>
                <a:gridCol w="1155600"/>
                <a:gridCol w="825840"/>
                <a:gridCol w="825480"/>
                <a:gridCol w="825480"/>
              </a:tblGrid>
              <a:tr h="298440">
                <a:tc gridSpan="8"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atient Disease Characteristic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03400"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cs-CZ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ybri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g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ende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thnicity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Disease Dur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&amp;Y Scor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-dop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Dement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5120"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D6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 year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tr-TR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Y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tr-TR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Y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5120"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D6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 year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tr-TR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Y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o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400"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D6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 year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tr-TR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Y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tr-TR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Y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6920"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NTL5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95120"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NTL6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3040"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NTL6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2-11T15:36:03Z</dcterms:created>
  <dc:creator>Emily Cronin-Furman</dc:creator>
  <dc:description/>
  <dc:language>en-US</dc:language>
  <cp:lastModifiedBy>Pat Trimmer</cp:lastModifiedBy>
  <dcterms:modified xsi:type="dcterms:W3CDTF">2012-12-11T20:36:23Z</dcterms:modified>
  <cp:revision>2</cp:revision>
  <dc:subject/>
  <dc:title>PowerPoint Presentation</dc:title>
</cp:coreProperties>
</file>